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</p:sldMasterIdLst>
  <p:sldIdLst>
    <p:sldId id="281" r:id="rId3"/>
    <p:sldId id="282" r:id="rId4"/>
    <p:sldId id="283" r:id="rId5"/>
    <p:sldId id="265" r:id="rId6"/>
    <p:sldId id="269" r:id="rId7"/>
    <p:sldId id="273" r:id="rId8"/>
    <p:sldId id="280" r:id="rId9"/>
    <p:sldId id="272" r:id="rId10"/>
    <p:sldId id="279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24" autoAdjust="0"/>
    <p:restoredTop sz="94660"/>
  </p:normalViewPr>
  <p:slideViewPr>
    <p:cSldViewPr>
      <p:cViewPr varScale="1">
        <p:scale>
          <a:sx n="87" d="100"/>
          <a:sy n="87" d="100"/>
        </p:scale>
        <p:origin x="-1445" y="-77"/>
      </p:cViewPr>
      <p:guideLst>
        <p:guide orient="horz" pos="2096"/>
        <p:guide pos="290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ableStyles" Target="tableStyle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693885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432717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691032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169708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180264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978456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448447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4472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453160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133902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6015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4/6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1185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604FCF22-F397-40E7-A3B8-31DE0843EFF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875"/>
          <a:stretch/>
        </p:blipFill>
        <p:spPr>
          <a:xfrm>
            <a:off x="467101" y="124886"/>
            <a:ext cx="8423620" cy="6317444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="" xmlns:a16="http://schemas.microsoft.com/office/drawing/2014/main" id="{C3CA7098-E0CC-4CA2-85DE-14B6AAF16604}"/>
              </a:ext>
            </a:extLst>
          </p:cNvPr>
          <p:cNvSpPr/>
          <p:nvPr/>
        </p:nvSpPr>
        <p:spPr>
          <a:xfrm>
            <a:off x="152400" y="93616"/>
            <a:ext cx="45680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 smtClean="0">
                <a:solidFill>
                  <a:prstClr val="black"/>
                </a:solidFill>
                <a:latin typeface="Arial" panose="020B0604020202020204"/>
              </a:rPr>
              <a:t>A</a:t>
            </a:r>
            <a:r>
              <a:rPr lang="en-US" altLang="zh-CN" sz="1400" b="1" dirty="0">
                <a:solidFill>
                  <a:prstClr val="black"/>
                </a:solidFill>
                <a:latin typeface="Arial" panose="020B0604020202020204"/>
              </a:rPr>
              <a:t>. 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="" xmlns:a16="http://schemas.microsoft.com/office/drawing/2014/main" id="{E0E64C4F-BDE0-46AC-B1B9-23B6058A8E3D}"/>
              </a:ext>
            </a:extLst>
          </p:cNvPr>
          <p:cNvSpPr txBox="1"/>
          <p:nvPr/>
        </p:nvSpPr>
        <p:spPr>
          <a:xfrm>
            <a:off x="8606596" y="1147776"/>
            <a:ext cx="6919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1</a:t>
            </a:r>
            <a:endParaRPr lang="zh-CN" altLang="en-US" sz="1400" b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="" xmlns:a16="http://schemas.microsoft.com/office/drawing/2014/main" id="{6B8DB2C3-19AE-473D-96D8-4CCBD524FDB0}"/>
              </a:ext>
            </a:extLst>
          </p:cNvPr>
          <p:cNvSpPr txBox="1"/>
          <p:nvPr/>
        </p:nvSpPr>
        <p:spPr>
          <a:xfrm>
            <a:off x="8564604" y="3554835"/>
            <a:ext cx="761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ψErv</a:t>
            </a:r>
            <a:endParaRPr lang="zh-CN" alt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="" xmlns:a16="http://schemas.microsoft.com/office/drawing/2014/main" id="{495E135B-0D84-4C7A-BEAE-02E9D39E20D6}"/>
              </a:ext>
            </a:extLst>
          </p:cNvPr>
          <p:cNvSpPr/>
          <p:nvPr/>
        </p:nvSpPr>
        <p:spPr>
          <a:xfrm>
            <a:off x="7086600" y="124886"/>
            <a:ext cx="304800" cy="11767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prstClr val="white"/>
              </a:solidFill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="" xmlns:a16="http://schemas.microsoft.com/office/drawing/2014/main" id="{3ED45C89-D4C9-4C45-8621-C052C81D380C}"/>
              </a:ext>
            </a:extLst>
          </p:cNvPr>
          <p:cNvSpPr/>
          <p:nvPr/>
        </p:nvSpPr>
        <p:spPr>
          <a:xfrm>
            <a:off x="6019800" y="5257805"/>
            <a:ext cx="304800" cy="118452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prstClr val="white"/>
              </a:solidFill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="" xmlns:a16="http://schemas.microsoft.com/office/drawing/2014/main" id="{0E25ABD1-045A-4D5A-AC70-4CE046587EAE}"/>
              </a:ext>
            </a:extLst>
          </p:cNvPr>
          <p:cNvCxnSpPr>
            <a:cxnSpLocks/>
          </p:cNvCxnSpPr>
          <p:nvPr/>
        </p:nvCxnSpPr>
        <p:spPr>
          <a:xfrm flipV="1">
            <a:off x="4994836" y="1342707"/>
            <a:ext cx="3647731" cy="26457"/>
          </a:xfrm>
          <a:prstGeom prst="line">
            <a:avLst/>
          </a:prstGeom>
          <a:ln w="254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="" xmlns:a16="http://schemas.microsoft.com/office/drawing/2014/main" id="{9F0D1086-4898-4DB7-A346-CBEDF94B210A}"/>
              </a:ext>
            </a:extLst>
          </p:cNvPr>
          <p:cNvCxnSpPr>
            <a:cxnSpLocks/>
          </p:cNvCxnSpPr>
          <p:nvPr/>
        </p:nvCxnSpPr>
        <p:spPr>
          <a:xfrm>
            <a:off x="1374297" y="2629135"/>
            <a:ext cx="2435703" cy="0"/>
          </a:xfrm>
          <a:prstGeom prst="line">
            <a:avLst/>
          </a:prstGeom>
          <a:ln w="254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="" xmlns:a16="http://schemas.microsoft.com/office/drawing/2014/main" id="{3892ACBD-3F1A-44F1-BDC2-4CA26874FB2E}"/>
              </a:ext>
            </a:extLst>
          </p:cNvPr>
          <p:cNvCxnSpPr>
            <a:cxnSpLocks/>
          </p:cNvCxnSpPr>
          <p:nvPr/>
        </p:nvCxnSpPr>
        <p:spPr>
          <a:xfrm>
            <a:off x="4191000" y="3840953"/>
            <a:ext cx="4451567" cy="21659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="" xmlns:a16="http://schemas.microsoft.com/office/drawing/2014/main" id="{4802DDD2-351A-4FB9-A9A4-ED190EA52FA1}"/>
              </a:ext>
            </a:extLst>
          </p:cNvPr>
          <p:cNvCxnSpPr>
            <a:cxnSpLocks/>
          </p:cNvCxnSpPr>
          <p:nvPr/>
        </p:nvCxnSpPr>
        <p:spPr>
          <a:xfrm>
            <a:off x="1409466" y="5137639"/>
            <a:ext cx="7268270" cy="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="" xmlns:a16="http://schemas.microsoft.com/office/drawing/2014/main" id="{8232D0B1-36ED-437F-9C1D-A2E84F06B19E}"/>
              </a:ext>
            </a:extLst>
          </p:cNvPr>
          <p:cNvCxnSpPr>
            <a:cxnSpLocks/>
          </p:cNvCxnSpPr>
          <p:nvPr/>
        </p:nvCxnSpPr>
        <p:spPr>
          <a:xfrm>
            <a:off x="2711233" y="6496601"/>
            <a:ext cx="5975567" cy="0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4DDC1B57-A520-45A4-8B94-B6C00C182860}"/>
              </a:ext>
            </a:extLst>
          </p:cNvPr>
          <p:cNvSpPr txBox="1"/>
          <p:nvPr/>
        </p:nvSpPr>
        <p:spPr>
          <a:xfrm>
            <a:off x="8216071" y="6496601"/>
            <a:ext cx="1110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</a:t>
            </a:r>
            <a:r>
              <a:rPr lang="en-US" altLang="zh-CN" sz="14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ALR</a:t>
            </a:r>
            <a:endParaRPr lang="zh-CN" altLang="en-US" sz="14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="" xmlns:a16="http://schemas.microsoft.com/office/drawing/2014/main" id="{AD9925D2-FED8-4851-9C61-7FFD791DB09E}"/>
              </a:ext>
            </a:extLst>
          </p:cNvPr>
          <p:cNvCxnSpPr>
            <a:cxnSpLocks/>
          </p:cNvCxnSpPr>
          <p:nvPr/>
        </p:nvCxnSpPr>
        <p:spPr>
          <a:xfrm>
            <a:off x="1380159" y="6495216"/>
            <a:ext cx="1286841" cy="6261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="" xmlns:a16="http://schemas.microsoft.com/office/drawing/2014/main" id="{6F93A4E8-80BB-4FE6-AEE4-3F29F99F0EA3}"/>
              </a:ext>
            </a:extLst>
          </p:cNvPr>
          <p:cNvSpPr txBox="1"/>
          <p:nvPr/>
        </p:nvSpPr>
        <p:spPr>
          <a:xfrm>
            <a:off x="7391400" y="-56522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XC motif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="" xmlns:a16="http://schemas.microsoft.com/office/drawing/2014/main" id="{CC1F5BDA-BBEF-4623-B594-EA1E87EA7D6D}"/>
              </a:ext>
            </a:extLst>
          </p:cNvPr>
          <p:cNvSpPr txBox="1"/>
          <p:nvPr/>
        </p:nvSpPr>
        <p:spPr>
          <a:xfrm>
            <a:off x="6285301" y="5065034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XC motif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5764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2793DD05-9B0C-4401-AF7F-84EABD192F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22"/>
          <a:stretch/>
        </p:blipFill>
        <p:spPr>
          <a:xfrm>
            <a:off x="457200" y="228600"/>
            <a:ext cx="8521395" cy="388620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="" xmlns:a16="http://schemas.microsoft.com/office/drawing/2014/main" id="{366C8065-CEFA-40B4-8E03-F4F433C3ED8B}"/>
              </a:ext>
            </a:extLst>
          </p:cNvPr>
          <p:cNvSpPr/>
          <p:nvPr/>
        </p:nvSpPr>
        <p:spPr>
          <a:xfrm>
            <a:off x="4572000" y="304800"/>
            <a:ext cx="304800" cy="121919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prstClr val="white"/>
              </a:solidFill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="" xmlns:a16="http://schemas.microsoft.com/office/drawing/2014/main" id="{00CEF2B7-5E6A-47F0-A07B-BDDB2F29A4E0}"/>
              </a:ext>
            </a:extLst>
          </p:cNvPr>
          <p:cNvCxnSpPr>
            <a:cxnSpLocks/>
          </p:cNvCxnSpPr>
          <p:nvPr/>
        </p:nvCxnSpPr>
        <p:spPr>
          <a:xfrm>
            <a:off x="1371600" y="1523999"/>
            <a:ext cx="1219200" cy="0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="" xmlns:a16="http://schemas.microsoft.com/office/drawing/2014/main" id="{A4A0C505-050F-4653-B1D6-588078CA1E59}"/>
              </a:ext>
            </a:extLst>
          </p:cNvPr>
          <p:cNvSpPr txBox="1"/>
          <p:nvPr/>
        </p:nvSpPr>
        <p:spPr>
          <a:xfrm>
            <a:off x="4860890" y="21939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XC motif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2">
            <a:extLst>
              <a:ext uri="{FF2B5EF4-FFF2-40B4-BE49-F238E27FC236}">
                <a16:creationId xmlns="" xmlns:a16="http://schemas.microsoft.com/office/drawing/2014/main" id="{A31BC1EB-33ED-4FC0-A0E5-E3BFE1838EB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301" y="4343400"/>
            <a:ext cx="7585398" cy="2236332"/>
          </a:xfrm>
          <a:prstGeom prst="rect">
            <a:avLst/>
          </a:prstGeom>
        </p:spPr>
      </p:pic>
      <p:sp>
        <p:nvSpPr>
          <p:cNvPr id="8" name="矩形 1">
            <a:extLst>
              <a:ext uri="{FF2B5EF4-FFF2-40B4-BE49-F238E27FC236}">
                <a16:creationId xmlns="" xmlns:a16="http://schemas.microsoft.com/office/drawing/2014/main" id="{6640CBC5-18F1-48BD-B61D-446C0BC61705}"/>
              </a:ext>
            </a:extLst>
          </p:cNvPr>
          <p:cNvSpPr/>
          <p:nvPr/>
        </p:nvSpPr>
        <p:spPr>
          <a:xfrm>
            <a:off x="358470" y="4341785"/>
            <a:ext cx="394454" cy="3067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  <a:latin typeface="Arial" panose="020B0604020202020204"/>
              </a:rPr>
              <a:t>B. </a:t>
            </a:r>
            <a:endParaRPr lang="zh-CN" altLang="en-US" sz="14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791493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568022BD-0BD6-4F1F-843B-60695DDEE177}"/>
              </a:ext>
            </a:extLst>
          </p:cNvPr>
          <p:cNvSpPr txBox="1"/>
          <p:nvPr/>
        </p:nvSpPr>
        <p:spPr>
          <a:xfrm>
            <a:off x="741485" y="1066800"/>
            <a:ext cx="7772400" cy="267765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 Secondary structure and alignment of PbQSOX.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alW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ignment of the QSOX genes in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.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rghei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b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odium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elii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y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odium falciparum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odium vivax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At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nio rerio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Dr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 sapiens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Hs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s musculus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Mm)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enorhabditis elegans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e) and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ypanosoma brucei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Tb) showing conserved amino acids. The predicted Trx1,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ψ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ALR domains are underlined with blue, green and yellow line, respectively. Three CXXC motifs (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AC,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RNC and Ct-CNYC) in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re highlighted in black rectangular frame. Identical: red, similar: sky blue, &gt;50% highlight. </a:t>
            </a:r>
            <a:r>
              <a:rPr lang="en-US" altLang="zh-CN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 acid sequence and the predicted secondary structure of PbQSOX. The predicted signal sequence is underlined. Trx1,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ψ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ALR domains are highlighted in blue, green and yellow, respectively. Three CXXC motifs (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PAC,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RNC and Ct-CNYC) in PbQSOX are highlighted in red and underlined in boldface. The CX6-8, CX6C and CX4C are underlined in boldface.</a:t>
            </a:r>
            <a:endParaRPr lang="zh-CN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27769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1851660" y="1567180"/>
            <a:ext cx="4953000" cy="2068195"/>
          </a:xfrm>
          <a:prstGeom prst="rect">
            <a:avLst/>
          </a:prstGeom>
        </p:spPr>
      </p:pic>
      <p:sp>
        <p:nvSpPr>
          <p:cNvPr id="26" name="文本框 56"/>
          <p:cNvSpPr txBox="1">
            <a:spLocks noChangeArrowheads="1"/>
          </p:cNvSpPr>
          <p:nvPr/>
        </p:nvSpPr>
        <p:spPr bwMode="auto">
          <a:xfrm>
            <a:off x="2160905" y="1242695"/>
            <a:ext cx="4643755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chizont                 Gametocyte             Ookinete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 flipV="1">
            <a:off x="6452870" y="3566795"/>
            <a:ext cx="2876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1143000" y="4114800"/>
            <a:ext cx="6993924" cy="138499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. Purified schizonts, gametocytes and ookinetes.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berghe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chizonts were obtained by culturing infected blood and enrichment on a 55%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ycodenz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cushion (v/v). Gametocytes were obtained from sulfadiazine-treated mice and enriched on a 48%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ycodenz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cushion (v/v) at 37°C. Ookinetes were obtained by culturing gametocyte-infected blood and enriched on a 62%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ycodenz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cushion (v/v). Smears were Giemsa-stained. Scale bar = 5 µm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08008" y="343657"/>
            <a:ext cx="7935748" cy="6705600"/>
            <a:chOff x="1093951" y="60184"/>
            <a:chExt cx="7935748" cy="6705600"/>
          </a:xfrm>
        </p:grpSpPr>
        <p:pic>
          <p:nvPicPr>
            <p:cNvPr id="2253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38400" y="790022"/>
              <a:ext cx="6287136" cy="545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48" name="直接连接符 47"/>
            <p:cNvCxnSpPr/>
            <p:nvPr/>
          </p:nvCxnSpPr>
          <p:spPr bwMode="auto">
            <a:xfrm>
              <a:off x="2451100" y="6765784"/>
              <a:ext cx="2921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/>
            <p:cNvGrpSpPr/>
            <p:nvPr/>
          </p:nvGrpSpPr>
          <p:grpSpPr>
            <a:xfrm>
              <a:off x="1093951" y="60184"/>
              <a:ext cx="7935748" cy="6096000"/>
              <a:chOff x="1093951" y="60184"/>
              <a:chExt cx="7935748" cy="6096000"/>
            </a:xfrm>
          </p:grpSpPr>
          <p:sp>
            <p:nvSpPr>
              <p:cNvPr id="5" name="矩形 4"/>
              <p:cNvSpPr/>
              <p:nvPr/>
            </p:nvSpPr>
            <p:spPr>
              <a:xfrm>
                <a:off x="1093951" y="60184"/>
                <a:ext cx="33331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/>
                  </a:rPr>
                  <a:t>A. </a:t>
                </a:r>
              </a:p>
            </p:txBody>
          </p:sp>
          <p:sp>
            <p:nvSpPr>
              <p:cNvPr id="8" name="文本框 26"/>
              <p:cNvSpPr txBox="1">
                <a:spLocks noChangeArrowheads="1"/>
              </p:cNvSpPr>
              <p:nvPr/>
            </p:nvSpPr>
            <p:spPr bwMode="auto">
              <a:xfrm>
                <a:off x="1497268" y="3997306"/>
                <a:ext cx="87227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okin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27"/>
              <p:cNvSpPr txBox="1">
                <a:spLocks noChangeArrowheads="1"/>
              </p:cNvSpPr>
              <p:nvPr/>
            </p:nvSpPr>
            <p:spPr bwMode="auto">
              <a:xfrm>
                <a:off x="1470145" y="2743200"/>
                <a:ext cx="899396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 </a:t>
                </a:r>
                <a:endPara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m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28"/>
              <p:cNvSpPr txBox="1">
                <a:spLocks noChangeArrowheads="1"/>
              </p:cNvSpPr>
              <p:nvPr/>
            </p:nvSpPr>
            <p:spPr bwMode="auto">
              <a:xfrm>
                <a:off x="1426487" y="3363916"/>
                <a:ext cx="943054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 </a:t>
                </a:r>
                <a:endPara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m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29"/>
              <p:cNvSpPr txBox="1">
                <a:spLocks noChangeArrowheads="1"/>
              </p:cNvSpPr>
              <p:nvPr/>
            </p:nvSpPr>
            <p:spPr bwMode="auto">
              <a:xfrm>
                <a:off x="1246867" y="1524120"/>
                <a:ext cx="1122674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 </a:t>
                </a:r>
                <a:endPara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metocy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30"/>
              <p:cNvSpPr txBox="1">
                <a:spLocks noChangeArrowheads="1"/>
              </p:cNvSpPr>
              <p:nvPr/>
            </p:nvSpPr>
            <p:spPr bwMode="auto">
              <a:xfrm>
                <a:off x="1321183" y="2117584"/>
                <a:ext cx="1048358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 </a:t>
                </a:r>
                <a:endPara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metocy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31"/>
              <p:cNvSpPr txBox="1">
                <a:spLocks noChangeArrowheads="1"/>
              </p:cNvSpPr>
              <p:nvPr/>
            </p:nvSpPr>
            <p:spPr bwMode="auto">
              <a:xfrm>
                <a:off x="1537128" y="1018401"/>
                <a:ext cx="83241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hizont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48"/>
              <p:cNvSpPr txBox="1">
                <a:spLocks noChangeArrowheads="1"/>
              </p:cNvSpPr>
              <p:nvPr/>
            </p:nvSpPr>
            <p:spPr bwMode="auto">
              <a:xfrm>
                <a:off x="6221169" y="512771"/>
                <a:ext cx="86836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49"/>
              <p:cNvSpPr txBox="1">
                <a:spLocks noChangeArrowheads="1"/>
              </p:cNvSpPr>
              <p:nvPr/>
            </p:nvSpPr>
            <p:spPr bwMode="auto">
              <a:xfrm>
                <a:off x="6791085" y="527529"/>
                <a:ext cx="95408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echst</a:t>
                </a:r>
              </a:p>
            </p:txBody>
          </p:sp>
          <p:sp>
            <p:nvSpPr>
              <p:cNvPr id="21" name="文本框 50"/>
              <p:cNvSpPr txBox="1">
                <a:spLocks noChangeArrowheads="1"/>
              </p:cNvSpPr>
              <p:nvPr/>
            </p:nvSpPr>
            <p:spPr bwMode="auto">
              <a:xfrm>
                <a:off x="7449747" y="343882"/>
                <a:ext cx="866777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b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r>
                  <a:rPr lang="en-US" altLang="zh-CN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 bwMode="auto">
              <a:xfrm>
                <a:off x="8077200" y="372340"/>
                <a:ext cx="952499" cy="461665"/>
              </a:xfrm>
              <a:prstGeom prst="rect">
                <a:avLst/>
              </a:prstGeom>
              <a:noFill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zh-CN" sz="1200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IC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>
                  <a:defRPr/>
                </a:pPr>
                <a:r>
                  <a:rPr lang="en-US" altLang="zh-CN" sz="12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echst</a:t>
                </a:r>
              </a:p>
            </p:txBody>
          </p:sp>
          <p:sp>
            <p:nvSpPr>
              <p:cNvPr id="23" name="文本框 52"/>
              <p:cNvSpPr txBox="1">
                <a:spLocks noChangeArrowheads="1"/>
              </p:cNvSpPr>
              <p:nvPr/>
            </p:nvSpPr>
            <p:spPr bwMode="auto">
              <a:xfrm>
                <a:off x="5638800" y="508865"/>
                <a:ext cx="72072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b</a:t>
                </a:r>
                <a:endParaRPr lang="zh-CN" alt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56"/>
              <p:cNvSpPr txBox="1">
                <a:spLocks noChangeArrowheads="1"/>
              </p:cNvSpPr>
              <p:nvPr/>
            </p:nvSpPr>
            <p:spPr bwMode="auto">
              <a:xfrm>
                <a:off x="3352800" y="60184"/>
                <a:ext cx="1377953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iton X-100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3"/>
              <p:cNvSpPr txBox="1">
                <a:spLocks noChangeArrowheads="1"/>
              </p:cNvSpPr>
              <p:nvPr/>
            </p:nvSpPr>
            <p:spPr bwMode="auto">
              <a:xfrm>
                <a:off x="1476485" y="4572000"/>
                <a:ext cx="89305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okin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58"/>
              <p:cNvSpPr txBox="1">
                <a:spLocks noChangeArrowheads="1"/>
              </p:cNvSpPr>
              <p:nvPr/>
            </p:nvSpPr>
            <p:spPr bwMode="auto">
              <a:xfrm>
                <a:off x="3180710" y="1203599"/>
                <a:ext cx="536576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P1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59"/>
              <p:cNvSpPr txBox="1">
                <a:spLocks noChangeArrowheads="1"/>
              </p:cNvSpPr>
              <p:nvPr/>
            </p:nvSpPr>
            <p:spPr bwMode="auto">
              <a:xfrm>
                <a:off x="3082925" y="2387328"/>
                <a:ext cx="673100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g377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60"/>
              <p:cNvSpPr txBox="1">
                <a:spLocks noChangeArrowheads="1"/>
              </p:cNvSpPr>
              <p:nvPr/>
            </p:nvSpPr>
            <p:spPr bwMode="auto">
              <a:xfrm>
                <a:off x="2997232" y="1806383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l-GR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61"/>
              <p:cNvSpPr txBox="1">
                <a:spLocks noChangeArrowheads="1"/>
              </p:cNvSpPr>
              <p:nvPr/>
            </p:nvSpPr>
            <p:spPr bwMode="auto">
              <a:xfrm>
                <a:off x="3078626" y="3571039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g377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62"/>
              <p:cNvSpPr txBox="1">
                <a:spLocks noChangeArrowheads="1"/>
              </p:cNvSpPr>
              <p:nvPr/>
            </p:nvSpPr>
            <p:spPr bwMode="auto">
              <a:xfrm>
                <a:off x="2991505" y="2997521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l-GR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63"/>
              <p:cNvSpPr txBox="1">
                <a:spLocks noChangeArrowheads="1"/>
              </p:cNvSpPr>
              <p:nvPr/>
            </p:nvSpPr>
            <p:spPr bwMode="auto">
              <a:xfrm>
                <a:off x="3018132" y="4179290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SOP25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64"/>
              <p:cNvSpPr txBox="1">
                <a:spLocks noChangeArrowheads="1"/>
              </p:cNvSpPr>
              <p:nvPr/>
            </p:nvSpPr>
            <p:spPr bwMode="auto">
              <a:xfrm>
                <a:off x="3045872" y="4787541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SOP25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67"/>
              <p:cNvSpPr txBox="1">
                <a:spLocks noChangeArrowheads="1"/>
              </p:cNvSpPr>
              <p:nvPr/>
            </p:nvSpPr>
            <p:spPr bwMode="auto">
              <a:xfrm>
                <a:off x="3001341" y="5638800"/>
                <a:ext cx="58005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F555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直接连接符 35"/>
              <p:cNvCxnSpPr/>
              <p:nvPr/>
            </p:nvCxnSpPr>
            <p:spPr bwMode="auto">
              <a:xfrm>
                <a:off x="2426163" y="1331797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 bwMode="auto">
              <a:xfrm>
                <a:off x="2413264" y="19651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 bwMode="auto">
              <a:xfrm>
                <a:off x="2438400" y="24985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 bwMode="auto">
              <a:xfrm>
                <a:off x="2451100" y="43273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 bwMode="auto">
              <a:xfrm>
                <a:off x="2438400" y="49369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 bwMode="auto">
              <a:xfrm>
                <a:off x="2451100" y="55465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 bwMode="auto">
              <a:xfrm>
                <a:off x="2447925" y="3108184"/>
                <a:ext cx="21907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 bwMode="auto">
              <a:xfrm>
                <a:off x="2451100" y="61561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文本框 65"/>
              <p:cNvSpPr txBox="1">
                <a:spLocks noChangeArrowheads="1"/>
              </p:cNvSpPr>
              <p:nvPr/>
            </p:nvSpPr>
            <p:spPr bwMode="auto">
              <a:xfrm>
                <a:off x="2362200" y="4953000"/>
                <a:ext cx="720725" cy="4003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 err="1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GST</a:t>
                </a:r>
                <a:endParaRPr lang="en-US" altLang="zh-CN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a</a:t>
                </a:r>
                <a:endParaRPr lang="zh-CN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65"/>
              <p:cNvSpPr txBox="1">
                <a:spLocks noChangeArrowheads="1"/>
              </p:cNvSpPr>
              <p:nvPr/>
            </p:nvSpPr>
            <p:spPr bwMode="auto">
              <a:xfrm>
                <a:off x="2388946" y="5638800"/>
                <a:ext cx="720725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F488</a:t>
                </a:r>
                <a:endParaRPr lang="zh-CN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64"/>
              <p:cNvSpPr txBox="1">
                <a:spLocks noChangeArrowheads="1"/>
              </p:cNvSpPr>
              <p:nvPr/>
            </p:nvSpPr>
            <p:spPr bwMode="auto">
              <a:xfrm>
                <a:off x="3022025" y="5383551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SOP25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3"/>
              <p:cNvSpPr txBox="1">
                <a:spLocks noChangeArrowheads="1"/>
              </p:cNvSpPr>
              <p:nvPr/>
            </p:nvSpPr>
            <p:spPr bwMode="auto">
              <a:xfrm>
                <a:off x="1436815" y="5819617"/>
                <a:ext cx="93272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okin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65"/>
              <p:cNvSpPr txBox="1">
                <a:spLocks noChangeArrowheads="1"/>
              </p:cNvSpPr>
              <p:nvPr/>
            </p:nvSpPr>
            <p:spPr bwMode="auto">
              <a:xfrm>
                <a:off x="2348628" y="4376847"/>
                <a:ext cx="720725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s21</a:t>
                </a:r>
                <a:endParaRPr lang="zh-CN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48"/>
              <p:cNvSpPr txBox="1">
                <a:spLocks noChangeArrowheads="1"/>
              </p:cNvSpPr>
              <p:nvPr/>
            </p:nvSpPr>
            <p:spPr bwMode="auto">
              <a:xfrm>
                <a:off x="2944569" y="529408"/>
                <a:ext cx="86836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49"/>
              <p:cNvSpPr txBox="1">
                <a:spLocks noChangeArrowheads="1"/>
              </p:cNvSpPr>
              <p:nvPr/>
            </p:nvSpPr>
            <p:spPr bwMode="auto">
              <a:xfrm>
                <a:off x="3514485" y="544166"/>
                <a:ext cx="95408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echst</a:t>
                </a:r>
              </a:p>
            </p:txBody>
          </p:sp>
          <p:sp>
            <p:nvSpPr>
              <p:cNvPr id="55" name="文本框 50"/>
              <p:cNvSpPr txBox="1">
                <a:spLocks noChangeArrowheads="1"/>
              </p:cNvSpPr>
              <p:nvPr/>
            </p:nvSpPr>
            <p:spPr bwMode="auto">
              <a:xfrm>
                <a:off x="4173147" y="360519"/>
                <a:ext cx="866777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b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r>
                  <a:rPr lang="en-US" altLang="zh-CN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 bwMode="auto">
              <a:xfrm>
                <a:off x="4800600" y="360519"/>
                <a:ext cx="952499" cy="461665"/>
              </a:xfrm>
              <a:prstGeom prst="rect">
                <a:avLst/>
              </a:prstGeom>
              <a:noFill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zh-CN" sz="1200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IC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>
                  <a:defRPr/>
                </a:pPr>
                <a:r>
                  <a:rPr lang="en-US" altLang="zh-CN" sz="12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echst</a:t>
                </a:r>
              </a:p>
            </p:txBody>
          </p:sp>
          <p:sp>
            <p:nvSpPr>
              <p:cNvPr id="57" name="文本框 52"/>
              <p:cNvSpPr txBox="1">
                <a:spLocks noChangeArrowheads="1"/>
              </p:cNvSpPr>
              <p:nvPr/>
            </p:nvSpPr>
            <p:spPr bwMode="auto">
              <a:xfrm>
                <a:off x="2460136" y="538568"/>
                <a:ext cx="72072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b="1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b</a:t>
                </a:r>
                <a:endParaRPr lang="zh-CN" alt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8" name="直接连接符 57"/>
              <p:cNvCxnSpPr/>
              <p:nvPr/>
            </p:nvCxnSpPr>
            <p:spPr bwMode="auto">
              <a:xfrm>
                <a:off x="2501648" y="364984"/>
                <a:ext cx="290855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接连接符 65"/>
              <p:cNvCxnSpPr/>
              <p:nvPr/>
            </p:nvCxnSpPr>
            <p:spPr bwMode="auto">
              <a:xfrm>
                <a:off x="2438400" y="3717784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文本框 3"/>
              <p:cNvSpPr txBox="1">
                <a:spLocks noChangeArrowheads="1"/>
              </p:cNvSpPr>
              <p:nvPr/>
            </p:nvSpPr>
            <p:spPr bwMode="auto">
              <a:xfrm>
                <a:off x="1427261" y="5209401"/>
                <a:ext cx="94228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okinete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58"/>
              <p:cNvSpPr txBox="1">
                <a:spLocks noChangeArrowheads="1"/>
              </p:cNvSpPr>
              <p:nvPr/>
            </p:nvSpPr>
            <p:spPr bwMode="auto">
              <a:xfrm>
                <a:off x="6437605" y="1203184"/>
                <a:ext cx="536576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SP1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59"/>
              <p:cNvSpPr txBox="1">
                <a:spLocks noChangeArrowheads="1"/>
              </p:cNvSpPr>
              <p:nvPr/>
            </p:nvSpPr>
            <p:spPr bwMode="auto">
              <a:xfrm>
                <a:off x="6339820" y="2386913"/>
                <a:ext cx="673100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g377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60"/>
              <p:cNvSpPr txBox="1">
                <a:spLocks noChangeArrowheads="1"/>
              </p:cNvSpPr>
              <p:nvPr/>
            </p:nvSpPr>
            <p:spPr bwMode="auto">
              <a:xfrm>
                <a:off x="6254127" y="1805968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l-GR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61"/>
              <p:cNvSpPr txBox="1">
                <a:spLocks noChangeArrowheads="1"/>
              </p:cNvSpPr>
              <p:nvPr/>
            </p:nvSpPr>
            <p:spPr bwMode="auto">
              <a:xfrm>
                <a:off x="6335521" y="3570624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g377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62"/>
              <p:cNvSpPr txBox="1">
                <a:spLocks noChangeArrowheads="1"/>
              </p:cNvSpPr>
              <p:nvPr/>
            </p:nvSpPr>
            <p:spPr bwMode="auto">
              <a:xfrm>
                <a:off x="6248400" y="2997106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l-GR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63"/>
              <p:cNvSpPr txBox="1">
                <a:spLocks noChangeArrowheads="1"/>
              </p:cNvSpPr>
              <p:nvPr/>
            </p:nvSpPr>
            <p:spPr bwMode="auto">
              <a:xfrm>
                <a:off x="6275027" y="4178875"/>
                <a:ext cx="809627" cy="2463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SOP25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接连接符 76"/>
              <p:cNvCxnSpPr/>
              <p:nvPr/>
            </p:nvCxnSpPr>
            <p:spPr bwMode="auto">
              <a:xfrm>
                <a:off x="5727899" y="1331382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 bwMode="auto">
              <a:xfrm>
                <a:off x="5715000" y="1964769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 bwMode="auto">
              <a:xfrm>
                <a:off x="5740136" y="2498169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79"/>
              <p:cNvCxnSpPr/>
              <p:nvPr/>
            </p:nvCxnSpPr>
            <p:spPr bwMode="auto">
              <a:xfrm>
                <a:off x="5752836" y="4326969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/>
              <p:nvPr/>
            </p:nvCxnSpPr>
            <p:spPr bwMode="auto">
              <a:xfrm>
                <a:off x="5749661" y="3107769"/>
                <a:ext cx="219075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/>
              <p:cNvCxnSpPr/>
              <p:nvPr/>
            </p:nvCxnSpPr>
            <p:spPr bwMode="auto">
              <a:xfrm>
                <a:off x="5740136" y="3717369"/>
                <a:ext cx="292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57"/>
              <p:cNvCxnSpPr/>
              <p:nvPr/>
            </p:nvCxnSpPr>
            <p:spPr bwMode="auto">
              <a:xfrm>
                <a:off x="5715000" y="381000"/>
                <a:ext cx="290855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文本框 56"/>
              <p:cNvSpPr txBox="1">
                <a:spLocks noChangeArrowheads="1"/>
              </p:cNvSpPr>
              <p:nvPr/>
            </p:nvSpPr>
            <p:spPr bwMode="auto">
              <a:xfrm>
                <a:off x="6396330" y="83636"/>
                <a:ext cx="1377953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─ Triton X-100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457200" y="4014787"/>
            <a:ext cx="8153400" cy="246221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ocalization of </a:t>
            </a:r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y IFA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foca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ages of QSOX in W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. berghe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+Triton X-100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r without (–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riton X-100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mbrane permeabilization. Anti-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PbQSOX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sera,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b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1: 500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as used as the primary antibodies (green). The antibodies agains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MSP1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r schizonts, Pbg377 for femal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metocytes/gamete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α-tubulin for mal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metocytes/gamete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and PSOP25 for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okinetes,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sed to label different stages (re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. Nuclei were stained with Hoechst (1:1000) (blue)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negative controls: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WT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okinetes (+TX) labeled with the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GST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ntrol sera or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with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secondary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ntibodies only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AF488, Alexa Fluor 488, and AF555, Alexa Fluor 555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.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cal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ars =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DIC, differential interference contrast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as not detecte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porozoites.  Sporozoites were permeabilize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ith Triton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X-100 an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bed with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PbQSOX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tisera (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b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GST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ntrol mous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era, and anti-Hsp70 sera,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espectively. Nuclei were counter-stained by Hoechst (blue). Scale bars= 5 µm. BF, bright field. Merge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oechst +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F488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1828800" y="381000"/>
            <a:ext cx="5334000" cy="3468606"/>
            <a:chOff x="1828800" y="381000"/>
            <a:chExt cx="5334000" cy="3468606"/>
          </a:xfrm>
        </p:grpSpPr>
        <p:pic>
          <p:nvPicPr>
            <p:cNvPr id="2355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5712" y="591651"/>
              <a:ext cx="3267888" cy="3257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矩形 2"/>
            <p:cNvSpPr/>
            <p:nvPr/>
          </p:nvSpPr>
          <p:spPr>
            <a:xfrm>
              <a:off x="1828800" y="381000"/>
              <a:ext cx="33331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Arial" panose="020B0604020202020204"/>
                </a:rPr>
                <a:t>B. </a:t>
              </a:r>
            </a:p>
          </p:txBody>
        </p:sp>
        <p:sp>
          <p:nvSpPr>
            <p:cNvPr id="57" name="文本框 52"/>
            <p:cNvSpPr txBox="1">
              <a:spLocks noChangeArrowheads="1"/>
            </p:cNvSpPr>
            <p:nvPr/>
          </p:nvSpPr>
          <p:spPr bwMode="auto">
            <a:xfrm>
              <a:off x="2979420" y="382489"/>
              <a:ext cx="3040380" cy="460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sz="1200" b="1" dirty="0">
                  <a:solidFill>
                    <a:schemeClr val="bg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F </a:t>
              </a:r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</a:t>
              </a:r>
              <a:r>
                <a:rPr lang="en-US" altLang="zh-CN" sz="12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Hoechst</a:t>
              </a:r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F488</a:t>
              </a:r>
              <a:r>
                <a:rPr lang="en-US" altLang="zh-CN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   </a:t>
              </a:r>
              <a:r>
                <a:rPr lang="en-US" altLang="zh-CN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erge  </a:t>
              </a:r>
              <a:endParaRPr lang="zh-CN" alt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5854065" y="907564"/>
              <a:ext cx="184731" cy="276999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endPara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5854065" y="1661944"/>
              <a:ext cx="526106" cy="276999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r>
                <a:rPr lang="en-US" altLang="zh-CN" sz="12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Ab</a:t>
              </a:r>
              <a:endPara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5854065" y="2364254"/>
              <a:ext cx="1308735" cy="27559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b="1" dirty="0" err="1" smtClean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GST</a:t>
              </a:r>
              <a:r>
                <a:rPr lang="en-US" altLang="zh-CN" sz="1200" b="1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</a:t>
              </a:r>
              <a:r>
                <a:rPr lang="en-US" altLang="zh-CN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era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5854065" y="3153559"/>
              <a:ext cx="1308735" cy="27559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Hsp70</a:t>
              </a:r>
            </a:p>
          </p:txBody>
        </p:sp>
        <p:cxnSp>
          <p:nvCxnSpPr>
            <p:cNvPr id="9" name="直接连接符 8"/>
            <p:cNvCxnSpPr/>
            <p:nvPr/>
          </p:nvCxnSpPr>
          <p:spPr>
            <a:xfrm>
              <a:off x="5517515" y="3661559"/>
              <a:ext cx="280035" cy="4445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10"/>
            <p:cNvSpPr/>
            <p:nvPr/>
          </p:nvSpPr>
          <p:spPr>
            <a:xfrm>
              <a:off x="5854065" y="815203"/>
              <a:ext cx="4844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b</a:t>
              </a:r>
              <a:endParaRPr lang="en-GB" sz="1200" b="1" dirty="0"/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WB-KO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4140" y="2487295"/>
            <a:ext cx="1709420" cy="1938655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>
            <a:off x="1052100" y="31198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pSp>
        <p:nvGrpSpPr>
          <p:cNvPr id="15" name="组合 14"/>
          <p:cNvGrpSpPr/>
          <p:nvPr/>
        </p:nvGrpSpPr>
        <p:grpSpPr>
          <a:xfrm>
            <a:off x="1532042" y="304800"/>
            <a:ext cx="5325958" cy="1621722"/>
            <a:chOff x="1954422" y="1205260"/>
            <a:chExt cx="5068184" cy="2099326"/>
          </a:xfrm>
        </p:grpSpPr>
        <p:cxnSp>
          <p:nvCxnSpPr>
            <p:cNvPr id="38" name="Straight Arrow Connector 37"/>
            <p:cNvCxnSpPr/>
            <p:nvPr/>
          </p:nvCxnSpPr>
          <p:spPr>
            <a:xfrm>
              <a:off x="4889006" y="2438400"/>
              <a:ext cx="0" cy="4572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3276600" y="1765060"/>
              <a:ext cx="374600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ight Arrow 4"/>
            <p:cNvSpPr/>
            <p:nvPr/>
          </p:nvSpPr>
          <p:spPr>
            <a:xfrm>
              <a:off x="4343289" y="1612977"/>
              <a:ext cx="1219409" cy="355108"/>
            </a:xfrm>
            <a:prstGeom prst="right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qsox</a:t>
              </a:r>
              <a:endParaRPr lang="en-US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3505200" y="1534569"/>
              <a:ext cx="228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4356620" y="1529162"/>
              <a:ext cx="2528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3471963" y="1205260"/>
              <a:ext cx="255198" cy="317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361433" y="1211744"/>
              <a:ext cx="255198" cy="317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>
              <a:off x="3498561" y="2970974"/>
              <a:ext cx="228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>
              <a:off x="4267200" y="2970974"/>
              <a:ext cx="2528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3478602" y="2653846"/>
              <a:ext cx="255198" cy="317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311364" y="2666861"/>
              <a:ext cx="255198" cy="317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973358" y="1600330"/>
              <a:ext cx="823110" cy="356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T locus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954590" y="2947834"/>
              <a:ext cx="1523988" cy="356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combined locus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954422" y="2203556"/>
              <a:ext cx="841897" cy="356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struct</a:t>
              </a:r>
            </a:p>
          </p:txBody>
        </p:sp>
        <p:sp>
          <p:nvSpPr>
            <p:cNvPr id="4" name="Rectangle 3"/>
            <p:cNvSpPr/>
            <p:nvPr/>
          </p:nvSpPr>
          <p:spPr>
            <a:xfrm>
              <a:off x="3881630" y="1708330"/>
              <a:ext cx="454408" cy="164402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UTR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5570063" y="1692382"/>
              <a:ext cx="449737" cy="1453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UTR</a:t>
              </a:r>
            </a:p>
          </p:txBody>
        </p:sp>
        <p:sp>
          <p:nvSpPr>
            <p:cNvPr id="60" name="Right Arrow 59"/>
            <p:cNvSpPr/>
            <p:nvPr/>
          </p:nvSpPr>
          <p:spPr>
            <a:xfrm>
              <a:off x="4347062" y="2135867"/>
              <a:ext cx="1121198" cy="302533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hfr</a:t>
              </a:r>
              <a:endParaRPr lang="en-US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881849" y="2214966"/>
              <a:ext cx="449737" cy="1453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UTR</a:t>
              </a: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5557857" y="2213322"/>
              <a:ext cx="449737" cy="1453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UTR</a:t>
              </a:r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3271725" y="3145443"/>
              <a:ext cx="37338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ight Arrow 63"/>
            <p:cNvSpPr/>
            <p:nvPr/>
          </p:nvSpPr>
          <p:spPr>
            <a:xfrm>
              <a:off x="4331194" y="2970974"/>
              <a:ext cx="1226662" cy="310928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hfr</a:t>
              </a:r>
              <a:endParaRPr lang="en-US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3873994" y="3051522"/>
              <a:ext cx="449737" cy="1453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UTR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5557857" y="3051522"/>
              <a:ext cx="449737" cy="1453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UTR</a:t>
              </a:r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3944474" y="1921475"/>
              <a:ext cx="366790" cy="2918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H="1">
              <a:off x="3902175" y="1921475"/>
              <a:ext cx="384918" cy="2918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5657569" y="1921475"/>
              <a:ext cx="337181" cy="281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>
              <a:off x="5585661" y="1921475"/>
              <a:ext cx="346245" cy="281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4244061" y="2015631"/>
            <a:ext cx="2869383" cy="2401431"/>
            <a:chOff x="2713937" y="3174071"/>
            <a:chExt cx="2869383" cy="2401431"/>
          </a:xfrm>
        </p:grpSpPr>
        <p:sp>
          <p:nvSpPr>
            <p:cNvPr id="70" name="TextBox 80"/>
            <p:cNvSpPr txBox="1"/>
            <p:nvPr/>
          </p:nvSpPr>
          <p:spPr>
            <a:xfrm>
              <a:off x="2713937" y="3188637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3206617" y="3174071"/>
              <a:ext cx="2376703" cy="2401431"/>
              <a:chOff x="6745627" y="3400673"/>
              <a:chExt cx="2376703" cy="2401431"/>
            </a:xfrm>
          </p:grpSpPr>
          <p:grpSp>
            <p:nvGrpSpPr>
              <p:cNvPr id="18" name="组合 17"/>
              <p:cNvGrpSpPr/>
              <p:nvPr/>
            </p:nvGrpSpPr>
            <p:grpSpPr>
              <a:xfrm>
                <a:off x="6745627" y="3400673"/>
                <a:ext cx="2149032" cy="2401431"/>
                <a:chOff x="6618012" y="3434095"/>
                <a:chExt cx="2149032" cy="2401431"/>
              </a:xfrm>
            </p:grpSpPr>
            <p:sp>
              <p:nvSpPr>
                <p:cNvPr id="75" name="文本框 8"/>
                <p:cNvSpPr txBox="1">
                  <a:spLocks noChangeArrowheads="1"/>
                </p:cNvSpPr>
                <p:nvPr/>
              </p:nvSpPr>
              <p:spPr bwMode="auto">
                <a:xfrm>
                  <a:off x="6669488" y="5558527"/>
                  <a:ext cx="61436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r>
                    <a:rPr lang="en-US" altLang="zh-CN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" name="组合 16"/>
                <p:cNvGrpSpPr/>
                <p:nvPr/>
              </p:nvGrpSpPr>
              <p:grpSpPr>
                <a:xfrm>
                  <a:off x="6618012" y="3434095"/>
                  <a:ext cx="2149032" cy="2157630"/>
                  <a:chOff x="6388067" y="3366101"/>
                  <a:chExt cx="2149032" cy="2157630"/>
                </a:xfrm>
              </p:grpSpPr>
              <p:cxnSp>
                <p:nvCxnSpPr>
                  <p:cNvPr id="72" name="直接连接符 71"/>
                  <p:cNvCxnSpPr/>
                  <p:nvPr/>
                </p:nvCxnSpPr>
                <p:spPr bwMode="auto">
                  <a:xfrm>
                    <a:off x="6870165" y="3656590"/>
                    <a:ext cx="72263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3" name="文本框 2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25306" y="3376476"/>
                    <a:ext cx="829446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QSOX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文本框 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781448" y="3366101"/>
                    <a:ext cx="755651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1680" indent="-28448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1730" indent="-22733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598930" indent="-22733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6130" indent="-22733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3330" indent="-22733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0530" indent="-22733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7730" indent="-22733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4930" indent="-22733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sp70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6" name="文本框 3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45774" y="3641075"/>
                    <a:ext cx="371476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文本框 3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388067" y="3819757"/>
                    <a:ext cx="57467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0-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3" name="文本框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81412" y="4306536"/>
                    <a:ext cx="572770" cy="4603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-</a:t>
                    </a:r>
                  </a:p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5-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4" name="文本框 3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45852" y="4675578"/>
                    <a:ext cx="57467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0-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5" name="文本框 3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43439" y="4971923"/>
                    <a:ext cx="573087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35-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6" name="文本框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38395" y="5246732"/>
                    <a:ext cx="57467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5-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文本框 1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70136" y="3656412"/>
                    <a:ext cx="666751" cy="2755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9" name="文本框 1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93235" y="3656403"/>
                    <a:ext cx="666751" cy="2755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O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1" name="文本框 1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764938" y="3656325"/>
                    <a:ext cx="666751" cy="2755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3" name="直接连接符 92"/>
                  <p:cNvCxnSpPr/>
                  <p:nvPr/>
                </p:nvCxnSpPr>
                <p:spPr bwMode="auto">
                  <a:xfrm flipV="1">
                    <a:off x="7733911" y="3653221"/>
                    <a:ext cx="752556" cy="3104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5" name="文本框 3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00741" y="4059265"/>
                    <a:ext cx="57467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10-</a:t>
                    </a:r>
                    <a:endParaRPr lang="zh-CN" altLang="en-US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92" name="文本框 14"/>
              <p:cNvSpPr txBox="1">
                <a:spLocks noChangeArrowheads="1"/>
              </p:cNvSpPr>
              <p:nvPr/>
            </p:nvSpPr>
            <p:spPr bwMode="auto">
              <a:xfrm>
                <a:off x="8455579" y="3687722"/>
                <a:ext cx="666751" cy="2755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" name="Group 20"/>
          <p:cNvGrpSpPr/>
          <p:nvPr/>
        </p:nvGrpSpPr>
        <p:grpSpPr>
          <a:xfrm>
            <a:off x="1052100" y="2140179"/>
            <a:ext cx="2914471" cy="1949362"/>
            <a:chOff x="5543729" y="463638"/>
            <a:chExt cx="2914471" cy="1949362"/>
          </a:xfrm>
        </p:grpSpPr>
        <p:sp>
          <p:nvSpPr>
            <p:cNvPr id="16" name="文本框 33"/>
            <p:cNvSpPr txBox="1">
              <a:spLocks noChangeArrowheads="1"/>
            </p:cNvSpPr>
            <p:nvPr/>
          </p:nvSpPr>
          <p:spPr bwMode="auto">
            <a:xfrm>
              <a:off x="6357487" y="1229332"/>
              <a:ext cx="5746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0-</a:t>
              </a:r>
            </a:p>
          </p:txBody>
        </p:sp>
        <p:sp>
          <p:nvSpPr>
            <p:cNvPr id="22" name="文本框 34"/>
            <p:cNvSpPr txBox="1">
              <a:spLocks noChangeArrowheads="1"/>
            </p:cNvSpPr>
            <p:nvPr/>
          </p:nvSpPr>
          <p:spPr bwMode="auto">
            <a:xfrm>
              <a:off x="6357461" y="1494875"/>
              <a:ext cx="574675" cy="245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1000-</a:t>
              </a:r>
            </a:p>
          </p:txBody>
        </p:sp>
        <p:sp>
          <p:nvSpPr>
            <p:cNvPr id="23" name="文本框 34"/>
            <p:cNvSpPr txBox="1">
              <a:spLocks noChangeArrowheads="1"/>
            </p:cNvSpPr>
            <p:nvPr/>
          </p:nvSpPr>
          <p:spPr bwMode="auto">
            <a:xfrm>
              <a:off x="6357461" y="1626320"/>
              <a:ext cx="5746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  750-</a:t>
              </a:r>
            </a:p>
          </p:txBody>
        </p:sp>
        <p:sp>
          <p:nvSpPr>
            <p:cNvPr id="25" name="文本框 34"/>
            <p:cNvSpPr txBox="1">
              <a:spLocks noChangeArrowheads="1"/>
            </p:cNvSpPr>
            <p:nvPr/>
          </p:nvSpPr>
          <p:spPr bwMode="auto">
            <a:xfrm>
              <a:off x="6357461" y="1739985"/>
              <a:ext cx="5746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  500-</a:t>
              </a:r>
            </a:p>
          </p:txBody>
        </p:sp>
        <p:sp>
          <p:nvSpPr>
            <p:cNvPr id="26" name="文本框 34"/>
            <p:cNvSpPr txBox="1">
              <a:spLocks noChangeArrowheads="1"/>
            </p:cNvSpPr>
            <p:nvPr/>
          </p:nvSpPr>
          <p:spPr bwMode="auto">
            <a:xfrm>
              <a:off x="6357461" y="1920960"/>
              <a:ext cx="574675" cy="245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  250-</a:t>
              </a:r>
            </a:p>
          </p:txBody>
        </p:sp>
        <p:sp>
          <p:nvSpPr>
            <p:cNvPr id="27" name="文本框 34"/>
            <p:cNvSpPr txBox="1">
              <a:spLocks noChangeArrowheads="1"/>
            </p:cNvSpPr>
            <p:nvPr/>
          </p:nvSpPr>
          <p:spPr bwMode="auto">
            <a:xfrm>
              <a:off x="6357461" y="2077805"/>
              <a:ext cx="5746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 100-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6402070" y="972820"/>
              <a:ext cx="2056130" cy="1440180"/>
              <a:chOff x="6402070" y="972820"/>
              <a:chExt cx="2056130" cy="1440180"/>
            </a:xfrm>
          </p:grpSpPr>
          <p:pic>
            <p:nvPicPr>
              <p:cNvPr id="12" name="图片 11" descr="F5B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788150" y="1181735"/>
                <a:ext cx="1670050" cy="1231265"/>
              </a:xfrm>
              <a:prstGeom prst="rect">
                <a:avLst/>
              </a:prstGeom>
            </p:spPr>
          </p:pic>
          <p:sp>
            <p:nvSpPr>
              <p:cNvPr id="29" name="文本框 33"/>
              <p:cNvSpPr txBox="1">
                <a:spLocks noChangeArrowheads="1"/>
              </p:cNvSpPr>
              <p:nvPr/>
            </p:nvSpPr>
            <p:spPr bwMode="auto">
              <a:xfrm>
                <a:off x="6402070" y="972820"/>
                <a:ext cx="205613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altLang="zh-CN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</a:t>
                </a:r>
                <a:r>
                  <a:rPr lang="en-US" altLang="zh-CN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    </a:t>
                </a:r>
                <a:r>
                  <a:rPr lang="en-US" altLang="zh-CN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     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sp>
          <p:nvSpPr>
            <p:cNvPr id="2" name="TextBox 80"/>
            <p:cNvSpPr txBox="1"/>
            <p:nvPr/>
          </p:nvSpPr>
          <p:spPr>
            <a:xfrm>
              <a:off x="5543729" y="463638"/>
              <a:ext cx="36449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486129" y="4800600"/>
            <a:ext cx="8124472" cy="160043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eration of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Δpbqsox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rasite line and verification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A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chematic representation for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owing the WT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ocus, the construct used for transfection and the recombined locus with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placed by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dhfr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assett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CR verification of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KO. Lanes 1 and 2 are WT parasites, while lanes 3 and 4 are </a:t>
            </a:r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rasites. Lanes 1 and 3, PCR with primers 1+2 (1344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; lanes 2 and 4, PCR with primers 1+3 (1333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 of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n WT and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Δpbqsox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KO) parasites. Lysates of ookinetes at 10 µg/lane were probed with anti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sera (1:50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. Protein loading was estimated b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-Hsp70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ra (Hsp70, 1:500)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1419225" y="292100"/>
          <a:ext cx="3705225" cy="2587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6" name="Prism 8" r:id="rId3" imgW="3726180" imgH="2621280" progId="Prism8.Document">
                  <p:embed/>
                </p:oleObj>
              </mc:Choice>
              <mc:Fallback>
                <p:oleObj name="Prism 8" r:id="rId3" imgW="3726180" imgH="2621280" progId="Prism8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19225" y="292100"/>
                        <a:ext cx="3705225" cy="25876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1221679" y="384771"/>
            <a:ext cx="64526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5018312" y="448939"/>
            <a:ext cx="64526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/>
        </p:nvGraphicFramePr>
        <p:xfrm>
          <a:off x="5303838" y="377825"/>
          <a:ext cx="2228850" cy="2462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7" name="Prism 8" r:id="rId5" imgW="2255520" imgH="2484120" progId="Prism8.Document">
                  <p:embed/>
                </p:oleObj>
              </mc:Choice>
              <mc:Fallback>
                <p:oleObj name="Prism 8" r:id="rId5" imgW="2255520" imgH="2484120" progId="Prism8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03838" y="377825"/>
                        <a:ext cx="2228850" cy="2462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/>
        </p:nvGraphicFramePr>
        <p:xfrm>
          <a:off x="1714500" y="2717800"/>
          <a:ext cx="2065338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8" name="Prism 8" r:id="rId7" imgW="2087880" imgH="2484120" progId="Prism8.Document">
                  <p:embed/>
                </p:oleObj>
              </mc:Choice>
              <mc:Fallback>
                <p:oleObj name="Prism 8" r:id="rId7" imgW="2087880" imgH="2484120" progId="Prism8.Document">
                  <p:embed/>
                  <p:pic>
                    <p:nvPicPr>
                      <p:cNvPr id="0" name="对象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14500" y="2717800"/>
                        <a:ext cx="2065338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/>
        </p:nvGraphicFramePr>
        <p:xfrm>
          <a:off x="5368925" y="2711450"/>
          <a:ext cx="2201863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9" name="Prism 8" r:id="rId9" imgW="2225040" imgH="2484120" progId="Prism8.Document">
                  <p:embed/>
                </p:oleObj>
              </mc:Choice>
              <mc:Fallback>
                <p:oleObj name="Prism 8" r:id="rId9" imgW="2225040" imgH="2484120" progId="Prism8.Document">
                  <p:embed/>
                  <p:pic>
                    <p:nvPicPr>
                      <p:cNvPr id="0" name="对象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368925" y="2711450"/>
                        <a:ext cx="2201863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文本框 10"/>
          <p:cNvSpPr txBox="1"/>
          <p:nvPr/>
        </p:nvSpPr>
        <p:spPr>
          <a:xfrm>
            <a:off x="5011373" y="2680931"/>
            <a:ext cx="64526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221678" y="2582274"/>
            <a:ext cx="64526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"/>
          <p:cNvSpPr txBox="1"/>
          <p:nvPr/>
        </p:nvSpPr>
        <p:spPr>
          <a:xfrm>
            <a:off x="685800" y="5105400"/>
            <a:ext cx="7719021" cy="138499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5. Phenotypic analyses of the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bqsox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asites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rowth of asexual blood stages.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arasitemia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as calculated in BALB/c mice (n = 5) after injection of 5×10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T or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pb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qsox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KO) parasites per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ouse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metocytemia at day 3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st infection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emale/male gametocyte ratios at day 3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st infection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umbers of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crogametes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t day 3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st infection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l data in the phenotypic analysis are from three independen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 an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results are shown as (mean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 SEM). 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 descr="S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069" y="1147465"/>
            <a:ext cx="3967895" cy="1990090"/>
          </a:xfrm>
          <a:prstGeom prst="rect">
            <a:avLst/>
          </a:prstGeom>
        </p:spPr>
      </p:pic>
      <p:sp>
        <p:nvSpPr>
          <p:cNvPr id="6" name="TextBox 8"/>
          <p:cNvSpPr txBox="1"/>
          <p:nvPr/>
        </p:nvSpPr>
        <p:spPr>
          <a:xfrm>
            <a:off x="389307" y="382905"/>
            <a:ext cx="5118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.                                                    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2"/>
          <p:cNvSpPr txBox="1">
            <a:spLocks noChangeArrowheads="1"/>
          </p:cNvSpPr>
          <p:nvPr/>
        </p:nvSpPr>
        <p:spPr bwMode="auto">
          <a:xfrm>
            <a:off x="762000" y="838200"/>
            <a:ext cx="35238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sz="14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F 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altLang="zh-CN" sz="14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Hoechst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21</a:t>
            </a:r>
            <a:r>
              <a:rPr lang="en-US" altLang="zh-CN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     </a:t>
            </a:r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Merge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endParaRPr lang="en-US" sz="1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8"/>
          <p:cNvSpPr txBox="1"/>
          <p:nvPr/>
        </p:nvSpPr>
        <p:spPr>
          <a:xfrm>
            <a:off x="4467860" y="2343785"/>
            <a:ext cx="42271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WT                                                            KO</a:t>
            </a:r>
          </a:p>
        </p:txBody>
      </p:sp>
      <p:sp>
        <p:nvSpPr>
          <p:cNvPr id="14" name="TextBox 8"/>
          <p:cNvSpPr txBox="1"/>
          <p:nvPr/>
        </p:nvSpPr>
        <p:spPr>
          <a:xfrm>
            <a:off x="3886200" y="2790092"/>
            <a:ext cx="5374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 µm</a:t>
            </a:r>
          </a:p>
        </p:txBody>
      </p:sp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7533" y="381000"/>
            <a:ext cx="4317522" cy="248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8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9599" y="2819400"/>
            <a:ext cx="4275455" cy="24039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3972195" y="381000"/>
            <a:ext cx="3898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57200" y="1905000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7200" y="213360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72163" y="444460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24537" y="287686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3962400" y="3048000"/>
            <a:ext cx="358659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"/>
          <p:cNvSpPr txBox="1"/>
          <p:nvPr/>
        </p:nvSpPr>
        <p:spPr>
          <a:xfrm>
            <a:off x="492403" y="5334000"/>
            <a:ext cx="8279765" cy="95410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6. Comparison of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okinetes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ocysts between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WT and </a:t>
            </a:r>
            <a:r>
              <a:rPr lang="en-US" altLang="zh-CN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Δpbqsox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parasites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WT or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Δpbqsox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KO) ookinetes were stained with anti-Pbs21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green). Nuclei were stained by Hoechst (blue). Scale bar = 5 µm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ercurochrome-stained representative images of 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n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tephensi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dguts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fected with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T and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Δpbqsox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KO) oocysts at 10 days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st feeding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cale bar = 200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REFSHAPE" val="488855188"/>
  <p:tag name="KSO_WM_UNIT_PLACING_PICTURE_USER_VIEWPORT" val="{&quot;height&quot;:2880,&quot;width&quot;:5914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965</Words>
  <Application>Microsoft Office PowerPoint</Application>
  <PresentationFormat>On-screen Show (4:3)</PresentationFormat>
  <Paragraphs>125</Paragraphs>
  <Slides>9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Office 主题</vt:lpstr>
      <vt:lpstr>1_Office 主题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wangcui</dc:creator>
  <cp:lastModifiedBy>Yaya</cp:lastModifiedBy>
  <cp:revision>194</cp:revision>
  <dcterms:created xsi:type="dcterms:W3CDTF">2015-10-12T16:43:00Z</dcterms:created>
  <dcterms:modified xsi:type="dcterms:W3CDTF">2020-04-06T21:35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84</vt:lpwstr>
  </property>
</Properties>
</file>